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394" autoAdjust="0"/>
  </p:normalViewPr>
  <p:slideViewPr>
    <p:cSldViewPr snapToGrid="0">
      <p:cViewPr varScale="1">
        <p:scale>
          <a:sx n="71" d="100"/>
          <a:sy n="71" d="100"/>
        </p:scale>
        <p:origin x="618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703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5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645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430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604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94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60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65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163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497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E3A69-5788-446B-AC39-545EB8AC144F}" type="datetimeFigureOut">
              <a:rPr lang="en-US" smtClean="0"/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4C15E-262F-448B-9D44-C3FCCD704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726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4660" y="503126"/>
            <a:ext cx="4539195" cy="635487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870056" y="457163"/>
            <a:ext cx="400184" cy="640083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7066895" y="457163"/>
            <a:ext cx="154473" cy="640083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7670093" y="-50872"/>
            <a:ext cx="80010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Alternative promoter in exon 7</a:t>
            </a:r>
            <a:endParaRPr lang="en-US" sz="1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6744076" y="-50872"/>
            <a:ext cx="80010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Alternative promoter in exon 5</a:t>
            </a:r>
            <a:endParaRPr lang="en-US" sz="1000" b="1" dirty="0"/>
          </a:p>
        </p:txBody>
      </p:sp>
      <p:sp>
        <p:nvSpPr>
          <p:cNvPr id="9" name="Rectangle 8"/>
          <p:cNvSpPr/>
          <p:nvPr/>
        </p:nvSpPr>
        <p:spPr>
          <a:xfrm>
            <a:off x="5519421" y="457163"/>
            <a:ext cx="133349" cy="640083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5035113" y="-56920"/>
            <a:ext cx="106027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Canonical promoter in exon 1</a:t>
            </a:r>
            <a:endParaRPr lang="en-US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-36397" y="79447"/>
            <a:ext cx="5047129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nonical and alterative promoter regions of </a:t>
            </a:r>
            <a:r>
              <a:rPr lang="en-US" i="1" dirty="0" smtClean="0"/>
              <a:t>PIWIL2 </a:t>
            </a:r>
            <a:r>
              <a:rPr lang="en-US" dirty="0" smtClean="0"/>
              <a:t>used in luciferase reporter vector assays.</a:t>
            </a:r>
          </a:p>
          <a:p>
            <a:r>
              <a:rPr lang="en-US" sz="1400" dirty="0" smtClean="0"/>
              <a:t>UCSC Genome Browser view of promoter regions (marked with red arrows) </a:t>
            </a:r>
            <a:r>
              <a:rPr lang="en-US" sz="1400" dirty="0"/>
              <a:t>a</a:t>
            </a:r>
            <a:r>
              <a:rPr lang="en-US" sz="1400" dirty="0" smtClean="0"/>
              <a:t>long with layered tracks of H3K4me1, H3K27ac and H3K4me3 chromatin modifications in ENCODE Tier 1 and Tier 2 cell lines (upper part), DNaseI hypersensitivity clusters, transcription factor ChIP-seq and putative transcription factor binding sites (middle </a:t>
            </a:r>
            <a:r>
              <a:rPr lang="en-US" sz="1400" dirty="0" smtClean="0"/>
              <a:t>part), </a:t>
            </a:r>
            <a:r>
              <a:rPr lang="en-US" sz="1400" dirty="0" smtClean="0"/>
              <a:t>as well as raw H3K4me1, H3K4me3, H3K27ac and H3K27me3 ChIP-seq signals for K562, HeLa-S3 and NT2D1 cell lines from ENCODE (lower part, two experiments for K562 cell line performed at different laboratories are shown).</a:t>
            </a:r>
          </a:p>
          <a:p>
            <a:endParaRPr lang="en-US" sz="1400" dirty="0" smtClean="0"/>
          </a:p>
          <a:p>
            <a:r>
              <a:rPr lang="en-US" sz="1400" b="1" u="sng" dirty="0"/>
              <a:t>Legend for </a:t>
            </a:r>
            <a:r>
              <a:rPr lang="en-US" sz="1400" b="1" u="sng" dirty="0" smtClean="0"/>
              <a:t>H3K4me3 </a:t>
            </a:r>
            <a:r>
              <a:rPr lang="en-US" sz="1400" b="1" u="sng" dirty="0"/>
              <a:t>layered </a:t>
            </a:r>
            <a:r>
              <a:rPr lang="en-US" sz="1400" b="1" u="sng" dirty="0" smtClean="0"/>
              <a:t>track</a:t>
            </a:r>
          </a:p>
          <a:p>
            <a:r>
              <a:rPr lang="en-US" sz="1400" b="1" u="sng" dirty="0" smtClean="0"/>
              <a:t>for </a:t>
            </a:r>
            <a:r>
              <a:rPr lang="en-US" sz="1400" b="1" u="sng" dirty="0"/>
              <a:t>7 ENCODE Tier </a:t>
            </a:r>
            <a:r>
              <a:rPr lang="en-US" sz="1400" b="1" u="sng" dirty="0" smtClean="0"/>
              <a:t>1 and Tier 2 </a:t>
            </a:r>
            <a:r>
              <a:rPr lang="en-US" sz="1400" b="1" u="sng" dirty="0"/>
              <a:t>cell lines</a:t>
            </a:r>
            <a:endParaRPr lang="en-US" sz="1400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4231" t="38775" r="83076" b="27949"/>
          <a:stretch/>
        </p:blipFill>
        <p:spPr>
          <a:xfrm>
            <a:off x="97122" y="3215194"/>
            <a:ext cx="631117" cy="930738"/>
          </a:xfrm>
          <a:prstGeom prst="rect">
            <a:avLst/>
          </a:prstGeom>
        </p:spPr>
      </p:pic>
      <p:cxnSp>
        <p:nvCxnSpPr>
          <p:cNvPr id="13" name="Straight Arrow Connector 12"/>
          <p:cNvCxnSpPr/>
          <p:nvPr/>
        </p:nvCxnSpPr>
        <p:spPr>
          <a:xfrm>
            <a:off x="4919829" y="1772143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6480405" y="1770350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7309461" y="1776446"/>
            <a:ext cx="230931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93078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139</Words>
  <Application>Microsoft Office PowerPoint</Application>
  <PresentationFormat>Широкоэкранный</PresentationFormat>
  <Paragraphs>8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dar gainetdinov</dc:creator>
  <cp:lastModifiedBy>ildar gainetdinov</cp:lastModifiedBy>
  <cp:revision>12</cp:revision>
  <dcterms:created xsi:type="dcterms:W3CDTF">2016-04-14T12:43:11Z</dcterms:created>
  <dcterms:modified xsi:type="dcterms:W3CDTF">2016-04-18T11:13:26Z</dcterms:modified>
</cp:coreProperties>
</file>